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7288213" cy="9574213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宋体" charset="0"/>
        <a:cs typeface="宋体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09">
          <p15:clr>
            <a:srgbClr val="A4A3A4"/>
          </p15:clr>
        </p15:guide>
        <p15:guide id="2" pos="231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4" autoAdjust="0"/>
    <p:restoredTop sz="98878" autoAdjust="0"/>
  </p:normalViewPr>
  <p:slideViewPr>
    <p:cSldViewPr snapToGrid="0">
      <p:cViewPr>
        <p:scale>
          <a:sx n="116" d="100"/>
          <a:sy n="116" d="100"/>
        </p:scale>
        <p:origin x="-1544" y="3968"/>
      </p:cViewPr>
      <p:guideLst>
        <p:guide orient="horz" pos="2809"/>
        <p:guide pos="231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buFont typeface="Arial" pitchFamily="34" charset="0"/>
              <a:buNone/>
              <a:defRPr sz="1200">
                <a:latin typeface="Arial" pitchFamily="34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buFont typeface="Arial" pitchFamily="34" charset="0"/>
              <a:buNone/>
              <a:defRPr sz="1200">
                <a:latin typeface="Arial" pitchFamily="34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4075" y="685800"/>
            <a:ext cx="2609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2053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buFont typeface="Arial" pitchFamily="34" charset="0"/>
              <a:buNone/>
              <a:defRPr sz="1200">
                <a:latin typeface="Arial" pitchFamily="34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Font typeface="Arial" charset="0"/>
              <a:buNone/>
              <a:defRPr sz="1200"/>
            </a:lvl1pPr>
          </a:lstStyle>
          <a:p>
            <a:fld id="{48C6A443-A345-AC4F-A7C1-F91F37AC193B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813277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宋体" pitchFamily="2" charset="-122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宋体" pitchFamily="2" charset="-122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宋体" pitchFamily="2" charset="-122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宋体" pitchFamily="2" charset="-122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宋体" pitchFamily="2" charset="-122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幻灯片图像占位符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24075" y="685800"/>
            <a:ext cx="26098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4099" name="备注占位符 2"/>
          <p:cNvSpPr>
            <a:spLocks noGrp="1"/>
          </p:cNvSpPr>
          <p:nvPr>
            <p:ph type="body" idx="1"/>
          </p:nvPr>
        </p:nvSpPr>
        <p:spPr>
          <a:noFill/>
          <a:extLs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zh-CN" altLang="en-US">
              <a:latin typeface="Arial" charset="0"/>
              <a:ea typeface="宋体" charset="0"/>
              <a:cs typeface="宋体" charset="0"/>
            </a:endParaRPr>
          </a:p>
        </p:txBody>
      </p:sp>
      <p:sp>
        <p:nvSpPr>
          <p:cNvPr id="4100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>
              <a:buFontTx/>
              <a:buNone/>
            </a:pPr>
            <a:fld id="{591AE09D-FEBF-B440-AFEE-4CFDA0383E9E}" type="slidenum">
              <a:rPr lang="zh-CN" altLang="en-US"/>
              <a:pPr>
                <a:buFontTx/>
                <a:buNone/>
              </a:pPr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70618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46616" y="2974212"/>
            <a:ext cx="6194981" cy="2052250"/>
          </a:xfrm>
        </p:spPr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93232" y="5425388"/>
            <a:ext cx="5101749" cy="244674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noProof="1" smtClean="0"/>
              <a:t>单击此处编辑母版副标题样式</a:t>
            </a:r>
            <a:endParaRPr lang="zh-CN" alt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0398CDA-89AF-4C4C-B21F-99B5300AC668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8720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09961A4-5734-8F4B-A52B-E84F54230F2F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2251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283954" y="383413"/>
            <a:ext cx="1639848" cy="8169109"/>
          </a:xfrm>
        </p:spPr>
        <p:txBody>
          <a:bodyPr vert="eaVert"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64410" y="383413"/>
            <a:ext cx="4798074" cy="8169109"/>
          </a:xfrm>
        </p:spPr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071A741-6EDA-3349-BC4F-071E000AC5BD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97924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775BB2E-FDA1-BE48-8805-91E3CA560D2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280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75719" y="6152319"/>
            <a:ext cx="6194981" cy="190154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75719" y="4057961"/>
            <a:ext cx="6194981" cy="209435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0B7349E-57E4-E746-9332-4181DECD4FD9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38298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64411" y="2233984"/>
            <a:ext cx="3218961" cy="631853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04841" y="2233984"/>
            <a:ext cx="3218961" cy="631853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94D2D1E-43DF-F040-9A9C-F868F03F895F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095191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64411" y="2143117"/>
            <a:ext cx="3220226" cy="8931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64411" y="3036267"/>
            <a:ext cx="3220226" cy="55162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702312" y="2143117"/>
            <a:ext cx="3221491" cy="8931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702312" y="3036267"/>
            <a:ext cx="3221491" cy="55162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20263BD-433F-D24D-BEFA-12D17EC18666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81507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B38B5C7-7C13-F244-8BB2-852F13EA2E4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553105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4F45EA4-ADAE-884E-BDBC-88659F26100F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178065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411" y="381196"/>
            <a:ext cx="2397772" cy="162229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849489" y="381196"/>
            <a:ext cx="4074314" cy="817132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64411" y="2003494"/>
            <a:ext cx="2397772" cy="654902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A3AA646-B718-1D4C-8318-C393D6B559B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72257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8541" y="6701949"/>
            <a:ext cx="4372928" cy="7912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428541" y="855474"/>
            <a:ext cx="4372928" cy="574452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428541" y="7493152"/>
            <a:ext cx="4372928" cy="112364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4AD2817-659D-7849-8731-8A659C824213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23230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364411" y="383413"/>
            <a:ext cx="6559392" cy="15957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364411" y="2233984"/>
            <a:ext cx="6559392" cy="6318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64411" y="8718739"/>
            <a:ext cx="1700583" cy="66487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buFontTx/>
              <a:buNone/>
              <a:defRPr sz="1400">
                <a:latin typeface="Arial" pitchFamily="34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490140" y="8718739"/>
            <a:ext cx="2307934" cy="66487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buFontTx/>
              <a:buNone/>
              <a:defRPr sz="1400">
                <a:latin typeface="Arial" pitchFamily="34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223219" y="8718739"/>
            <a:ext cx="1700583" cy="66487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Font typeface="Arial" charset="0"/>
              <a:buNone/>
              <a:defRPr sz="1400"/>
            </a:lvl1pPr>
          </a:lstStyle>
          <a:p>
            <a:fld id="{CA84705B-D789-1A48-B686-99039BE81622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宋体" pitchFamily="2" charset="-122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  <a:cs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  <a:cs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  <a:cs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  <a:cs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宋体" pitchFamily="2" charset="-122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  <a:cs typeface="宋体" pitchFamily="2" charset="-122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宋体" pitchFamily="2" charset="-122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  <a:cs typeface="宋体" pitchFamily="2" charset="-122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宋体" pitchFamily="2" charset="-122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7707814"/>
              </p:ext>
            </p:extLst>
          </p:nvPr>
        </p:nvGraphicFramePr>
        <p:xfrm>
          <a:off x="800497" y="2558788"/>
          <a:ext cx="6351387" cy="9399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8082"/>
                <a:gridCol w="198573"/>
                <a:gridCol w="186805"/>
                <a:gridCol w="210340"/>
                <a:gridCol w="198573"/>
                <a:gridCol w="198573"/>
                <a:gridCol w="198573"/>
                <a:gridCol w="198082"/>
                <a:gridCol w="198573"/>
                <a:gridCol w="199063"/>
                <a:gridCol w="198082"/>
                <a:gridCol w="198573"/>
                <a:gridCol w="198082"/>
                <a:gridCol w="198573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082"/>
                <a:gridCol w="199063"/>
                <a:gridCol w="198082"/>
                <a:gridCol w="198573"/>
                <a:gridCol w="198573"/>
                <a:gridCol w="198573"/>
              </a:tblGrid>
              <a:tr h="27155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71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49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p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p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075" name="TextBox 7"/>
          <p:cNvSpPr txBox="1">
            <a:spLocks noChangeArrowheads="1"/>
          </p:cNvSpPr>
          <p:nvPr/>
        </p:nvSpPr>
        <p:spPr bwMode="auto">
          <a:xfrm>
            <a:off x="27836" y="2574745"/>
            <a:ext cx="7967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6" name="TextBox 8"/>
          <p:cNvSpPr txBox="1">
            <a:spLocks noChangeArrowheads="1"/>
          </p:cNvSpPr>
          <p:nvPr/>
        </p:nvSpPr>
        <p:spPr bwMode="auto">
          <a:xfrm>
            <a:off x="94178" y="2867820"/>
            <a:ext cx="7303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7" name="TextBox 9"/>
          <p:cNvSpPr txBox="1">
            <a:spLocks noChangeArrowheads="1"/>
          </p:cNvSpPr>
          <p:nvPr/>
        </p:nvSpPr>
        <p:spPr bwMode="auto">
          <a:xfrm>
            <a:off x="142538" y="3166235"/>
            <a:ext cx="68200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8" name="TextBox 1"/>
          <p:cNvSpPr txBox="1">
            <a:spLocks noChangeArrowheads="1"/>
          </p:cNvSpPr>
          <p:nvPr/>
        </p:nvSpPr>
        <p:spPr bwMode="auto">
          <a:xfrm>
            <a:off x="734911" y="2261529"/>
            <a:ext cx="1434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2-1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84" name="Picture 14"/>
          <p:cNvPicPr>
            <a:picLocks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418" y="5663943"/>
            <a:ext cx="6371999" cy="71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15"/>
          <p:cNvPicPr>
            <a:picLocks noChangeArrowheads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780" y="3529203"/>
            <a:ext cx="6378451" cy="71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7"/>
          <p:cNvSpPr txBox="1">
            <a:spLocks noChangeArrowheads="1"/>
          </p:cNvSpPr>
          <p:nvPr/>
        </p:nvSpPr>
        <p:spPr bwMode="auto">
          <a:xfrm>
            <a:off x="28588" y="4707838"/>
            <a:ext cx="7967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8"/>
          <p:cNvSpPr txBox="1">
            <a:spLocks noChangeArrowheads="1"/>
          </p:cNvSpPr>
          <p:nvPr/>
        </p:nvSpPr>
        <p:spPr bwMode="auto">
          <a:xfrm>
            <a:off x="94930" y="5000913"/>
            <a:ext cx="7303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9"/>
          <p:cNvSpPr txBox="1">
            <a:spLocks noChangeArrowheads="1"/>
          </p:cNvSpPr>
          <p:nvPr/>
        </p:nvSpPr>
        <p:spPr bwMode="auto">
          <a:xfrm>
            <a:off x="143290" y="5299328"/>
            <a:ext cx="68200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"/>
          <p:cNvSpPr txBox="1">
            <a:spLocks noChangeArrowheads="1"/>
          </p:cNvSpPr>
          <p:nvPr/>
        </p:nvSpPr>
        <p:spPr bwMode="auto">
          <a:xfrm>
            <a:off x="735663" y="4394622"/>
            <a:ext cx="1434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M4-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16"/>
          <p:cNvPicPr>
            <a:picLocks noChangeArrowheads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3310" y="7799245"/>
            <a:ext cx="6370859" cy="71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3" name="表格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7887274"/>
              </p:ext>
            </p:extLst>
          </p:nvPr>
        </p:nvGraphicFramePr>
        <p:xfrm>
          <a:off x="802001" y="6824974"/>
          <a:ext cx="6351387" cy="9399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8082"/>
                <a:gridCol w="198573"/>
                <a:gridCol w="186805"/>
                <a:gridCol w="210340"/>
                <a:gridCol w="198573"/>
                <a:gridCol w="198573"/>
                <a:gridCol w="198573"/>
                <a:gridCol w="198082"/>
                <a:gridCol w="198573"/>
                <a:gridCol w="199063"/>
                <a:gridCol w="198082"/>
                <a:gridCol w="198573"/>
                <a:gridCol w="198082"/>
                <a:gridCol w="198573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082"/>
                <a:gridCol w="199063"/>
                <a:gridCol w="198082"/>
                <a:gridCol w="198573"/>
                <a:gridCol w="198573"/>
                <a:gridCol w="198573"/>
              </a:tblGrid>
              <a:tr h="27155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71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49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4" name="TextBox 7"/>
          <p:cNvSpPr txBox="1">
            <a:spLocks noChangeArrowheads="1"/>
          </p:cNvSpPr>
          <p:nvPr/>
        </p:nvSpPr>
        <p:spPr bwMode="auto">
          <a:xfrm>
            <a:off x="29340" y="6840931"/>
            <a:ext cx="7967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8"/>
          <p:cNvSpPr txBox="1">
            <a:spLocks noChangeArrowheads="1"/>
          </p:cNvSpPr>
          <p:nvPr/>
        </p:nvSpPr>
        <p:spPr bwMode="auto">
          <a:xfrm>
            <a:off x="95682" y="7134006"/>
            <a:ext cx="7303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9"/>
          <p:cNvSpPr txBox="1">
            <a:spLocks noChangeArrowheads="1"/>
          </p:cNvSpPr>
          <p:nvPr/>
        </p:nvSpPr>
        <p:spPr bwMode="auto">
          <a:xfrm>
            <a:off x="144042" y="7432421"/>
            <a:ext cx="68200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1"/>
          <p:cNvSpPr txBox="1">
            <a:spLocks noChangeArrowheads="1"/>
          </p:cNvSpPr>
          <p:nvPr/>
        </p:nvSpPr>
        <p:spPr bwMode="auto">
          <a:xfrm>
            <a:off x="736415" y="6527715"/>
            <a:ext cx="1434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M7-1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1"/>
          <p:cNvSpPr txBox="1">
            <a:spLocks noChangeArrowheads="1"/>
          </p:cNvSpPr>
          <p:nvPr/>
        </p:nvSpPr>
        <p:spPr bwMode="auto">
          <a:xfrm>
            <a:off x="737167" y="8594469"/>
            <a:ext cx="630463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</a:t>
            </a:r>
            <a:r>
              <a:rPr lang="en-US" altLang="zh-CN" sz="1200" b="1" dirty="0" smtClean="0">
                <a:latin typeface="Times New Roman"/>
                <a:cs typeface="Times New Roman"/>
              </a:rPr>
              <a:t>: </a:t>
            </a:r>
            <a:r>
              <a:rPr lang="en-US" altLang="zh-CN" sz="1200" b="1" dirty="0" smtClean="0">
                <a:latin typeface="Times New Roman"/>
                <a:cs typeface="Times New Roman"/>
              </a:rPr>
              <a:t>Fig. S2. </a:t>
            </a:r>
            <a:r>
              <a:rPr lang="en-US" altLang="zh-CN" sz="1200" b="1" dirty="0" smtClean="0">
                <a:latin typeface="Times New Roman"/>
                <a:cs typeface="Times New Roman"/>
              </a:rPr>
              <a:t>PCR </a:t>
            </a:r>
            <a:r>
              <a:rPr lang="en-US" altLang="zh-CN" sz="1200" b="1" dirty="0">
                <a:latin typeface="Times New Roman"/>
                <a:cs typeface="Times New Roman"/>
              </a:rPr>
              <a:t>profiles of the first 30 progeny isolates and their parental isolates which derived from four putative polymorphic markers those selected from </a:t>
            </a:r>
            <a:r>
              <a:rPr lang="en-US" altLang="zh-CN" sz="1200" b="1">
                <a:latin typeface="Times New Roman"/>
                <a:cs typeface="Times New Roman"/>
              </a:rPr>
              <a:t>BSA </a:t>
            </a:r>
            <a:r>
              <a:rPr lang="en-US" altLang="zh-CN" sz="1200" b="1" smtClean="0">
                <a:latin typeface="Times New Roman"/>
                <a:cs typeface="Times New Roman"/>
              </a:rPr>
              <a:t>analysis.</a:t>
            </a:r>
            <a:r>
              <a:rPr lang="zh-CN" altLang="zh-CN" sz="1200" smtClean="0"/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A,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irulent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V, virulent. Genotypes: A, the same with A parent (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V, the  same with V parent (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p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H, the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type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both parents; red, the recombinant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表格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9406049"/>
              </p:ext>
            </p:extLst>
          </p:nvPr>
        </p:nvGraphicFramePr>
        <p:xfrm>
          <a:off x="793275" y="4693417"/>
          <a:ext cx="6351387" cy="9399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8082"/>
                <a:gridCol w="198573"/>
                <a:gridCol w="186805"/>
                <a:gridCol w="210340"/>
                <a:gridCol w="198573"/>
                <a:gridCol w="198573"/>
                <a:gridCol w="198573"/>
                <a:gridCol w="198082"/>
                <a:gridCol w="198573"/>
                <a:gridCol w="199063"/>
                <a:gridCol w="198082"/>
                <a:gridCol w="198573"/>
                <a:gridCol w="198082"/>
                <a:gridCol w="198573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082"/>
                <a:gridCol w="199063"/>
                <a:gridCol w="198082"/>
                <a:gridCol w="198573"/>
                <a:gridCol w="198573"/>
                <a:gridCol w="198573"/>
              </a:tblGrid>
              <a:tr h="27155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71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49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9" name="表格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8990040"/>
              </p:ext>
            </p:extLst>
          </p:nvPr>
        </p:nvGraphicFramePr>
        <p:xfrm>
          <a:off x="791771" y="389323"/>
          <a:ext cx="6351387" cy="9399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8082"/>
                <a:gridCol w="198573"/>
                <a:gridCol w="186805"/>
                <a:gridCol w="210340"/>
                <a:gridCol w="198573"/>
                <a:gridCol w="198573"/>
                <a:gridCol w="198573"/>
                <a:gridCol w="198082"/>
                <a:gridCol w="198573"/>
                <a:gridCol w="199063"/>
                <a:gridCol w="198082"/>
                <a:gridCol w="198573"/>
                <a:gridCol w="198082"/>
                <a:gridCol w="198573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573"/>
                <a:gridCol w="198573"/>
                <a:gridCol w="198082"/>
                <a:gridCol w="198573"/>
                <a:gridCol w="198573"/>
                <a:gridCol w="198082"/>
                <a:gridCol w="199063"/>
                <a:gridCol w="198082"/>
                <a:gridCol w="198573"/>
                <a:gridCol w="198573"/>
                <a:gridCol w="198573"/>
              </a:tblGrid>
              <a:tr h="27155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en-US" altLang="zh-CN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en-US" altLang="zh-CN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71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</a:t>
                      </a:r>
                      <a:endParaRPr lang="zh-CN" altLang="en-US" sz="1100" b="0" kern="1200" dirty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72882" marR="72882" marT="63828" marB="638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493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p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0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1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6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7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28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0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1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2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3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4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100" b="0" kern="12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35</a:t>
                      </a:r>
                    </a:p>
                  </a:txBody>
                  <a:tcPr marL="72882" marR="72882" marT="63828" marB="63828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0" name="TextBox 7"/>
          <p:cNvSpPr txBox="1">
            <a:spLocks noChangeArrowheads="1"/>
          </p:cNvSpPr>
          <p:nvPr/>
        </p:nvSpPr>
        <p:spPr bwMode="auto">
          <a:xfrm>
            <a:off x="19110" y="405280"/>
            <a:ext cx="7967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8"/>
          <p:cNvSpPr txBox="1">
            <a:spLocks noChangeArrowheads="1"/>
          </p:cNvSpPr>
          <p:nvPr/>
        </p:nvSpPr>
        <p:spPr bwMode="auto">
          <a:xfrm>
            <a:off x="85452" y="698355"/>
            <a:ext cx="7303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9"/>
          <p:cNvSpPr txBox="1">
            <a:spLocks noChangeArrowheads="1"/>
          </p:cNvSpPr>
          <p:nvPr/>
        </p:nvSpPr>
        <p:spPr bwMode="auto">
          <a:xfrm>
            <a:off x="133812" y="996770"/>
            <a:ext cx="68200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 eaLnBrk="1" hangingPunct="1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1"/>
          <p:cNvSpPr txBox="1">
            <a:spLocks noChangeArrowheads="1"/>
          </p:cNvSpPr>
          <p:nvPr/>
        </p:nvSpPr>
        <p:spPr bwMode="auto">
          <a:xfrm>
            <a:off x="726185" y="92064"/>
            <a:ext cx="1434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2-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Picture 13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248" y="1359562"/>
            <a:ext cx="6407983" cy="71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9525">
          <a:solidFill>
            <a:schemeClr val="tx1"/>
          </a:solidFill>
          <a:prstDash val="dash"/>
          <a:round/>
        </a:ln>
      </a:spPr>
      <a:bodyPr/>
      <a:lstStyle>
        <a:defPPr>
          <a:defRPr/>
        </a:defPPr>
      </a:lstStyle>
    </a:sp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88</TotalTime>
  <Pages>0</Pages>
  <Words>489</Words>
  <Characters>0</Characters>
  <Application>Microsoft Macintosh PowerPoint</Application>
  <DocSecurity>0</DocSecurity>
  <PresentationFormat>自定义</PresentationFormat>
  <Lines>0</Lines>
  <Paragraphs>40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Manager/>
  <Company>Microsoft</Company>
  <LinksUpToDate>false</LinksUpToDate>
  <CharactersWithSpaces>0</CharactersWithSpaces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subject/>
  <dc:creator>walkinnet</dc:creator>
  <cp:keywords/>
  <dc:description/>
  <cp:lastModifiedBy>Qinghua Pan</cp:lastModifiedBy>
  <cp:revision>692</cp:revision>
  <dcterms:created xsi:type="dcterms:W3CDTF">2010-09-18T01:46:40Z</dcterms:created>
  <dcterms:modified xsi:type="dcterms:W3CDTF">2017-10-23T19:49:28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745</vt:lpwstr>
  </property>
</Properties>
</file>